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618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84FF37-4AA1-24B7-172A-1B49CA7711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491811F-00BB-E103-F3BD-0619F6A076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5B2785B-7350-ECAB-7290-C73B564A40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7AB95A-3767-4BDB-A7EF-C2479F7326CA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906BCE5-7885-A9D1-7ADC-02D1F11319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3480211-39BA-9CB0-A06B-BD1621BB73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5DB19-4F56-4949-8379-62BA31CFC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32835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E23358-D82E-79CA-A614-0022C367E2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7A51FDE-FB52-687C-5087-B6FE7EEC83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C732D7-C088-2155-87EB-DDC6BB0545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7AB95A-3767-4BDB-A7EF-C2479F7326CA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E100846-9FFC-A322-D7D8-40E5A14EDE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33409E1-36E0-CB3A-7352-FA1AE1F386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5DB19-4F56-4949-8379-62BA31CFC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21392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6D4F91E-74DD-DDEF-D633-383C270EEA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294279A-CA8B-C4BF-C153-EBCA7C3C15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F933ADC-96C0-EE69-00B4-5493E641C2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7AB95A-3767-4BDB-A7EF-C2479F7326CA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53C26D0-FBFB-B1AA-E7CE-53453E78C1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A363C31-76D0-2AA6-EA2E-3C306A552D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5DB19-4F56-4949-8379-62BA31CFC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0187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0B1AAA-E5F7-A07A-5F4E-F35BC0182B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9996773-BC85-2233-F10C-66F692E2E3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54F56CA-4C91-3E5E-5E70-39A98E52C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7AB95A-3767-4BDB-A7EF-C2479F7326CA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387553C-C492-331C-775D-ED217CC09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56C40DE-0D1A-5786-1E36-66E7BEF40F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5DB19-4F56-4949-8379-62BA31CFC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07366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FFDA09-2B14-A3CF-87E8-B218285DDF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F3B0708-2C35-3A37-9219-C6477FBCE6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814998D-E1F8-54BF-EAE3-81AA3819E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7AB95A-3767-4BDB-A7EF-C2479F7326CA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A7BFC0A-4ACA-1C49-58D9-5B34ED51F1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27EF5C-39D6-E55D-D9A0-73C7457B7B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5DB19-4F56-4949-8379-62BA31CFC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46375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E01797-EFD8-BE04-ADC9-143A25DAB2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176C046-6233-69BB-F3F5-2397195169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75FF665-4908-60D3-5D6C-CBE0FEE2D5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FB30E73-CFC0-233B-DFC1-81B6940A9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7AB95A-3767-4BDB-A7EF-C2479F7326CA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8ADBE81-9AE8-1215-A107-3D127519C0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04DB665-A90E-B73A-9FAA-6B3F2FC90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5DB19-4F56-4949-8379-62BA31CFC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9396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2558AD-D348-2A9D-A675-8B66A916C9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7468745-5783-8938-05BF-FE2B555CCC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B1839AA-AB92-915B-9784-902465A163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984D680-22D2-51D4-BA38-181BC89018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60CF030-3644-F848-0309-CCC11C11CB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2C0FC25-75AE-DA5F-E491-4CE776B346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7AB95A-3767-4BDB-A7EF-C2479F7326CA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211EC04-B216-3452-1EA8-D7F0896702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F4925A1-D5F5-9354-E58B-310CAFB44B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5DB19-4F56-4949-8379-62BA31CFC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03951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96A96C9-C496-0A32-C2F7-A5EE064FC6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5D0A68B-5F33-0C97-7561-AF300799FE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7AB95A-3767-4BDB-A7EF-C2479F7326CA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2DE4D70-1613-EAA3-4D55-28C429716A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34F2B4E-7784-8163-1A53-A333981C68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5DB19-4F56-4949-8379-62BA31CFC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35265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504A184-EC1D-B985-EAA3-C12E95A52D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7AB95A-3767-4BDB-A7EF-C2479F7326CA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37265F8-9625-AD2E-0526-259003061D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A7D12A4-ACB1-6F43-6F5F-86822BAF75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5DB19-4F56-4949-8379-62BA31CFC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1103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55141CE-C7BA-16D7-5A0F-162F622E0E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A9EEAA5-9B48-C91B-A7C1-621A2E8CDE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70E0BA6-842E-97B2-7DAE-B408552D66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DECFADC-54DB-7869-09E2-7125E70E30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7AB95A-3767-4BDB-A7EF-C2479F7326CA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E4607E2-4D84-1664-DC4B-7B381E9E9C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C999452-CB6B-9DE9-A784-2F077E00AA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5DB19-4F56-4949-8379-62BA31CFC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1814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E6FA21C-8825-EDE9-C6FD-E9DA24E7AB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0596A69-DF7B-B875-AB7A-BFA854AA915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27DF346-CBAA-29B2-5B6B-BF45666FDB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1F8151F-76BA-BF9B-9A90-49DD9939F1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7AB95A-3767-4BDB-A7EF-C2479F7326CA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7127E7C-14D4-4D68-CE1F-E3A95B1F4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03548B0-5438-6F25-5D19-EADEC6871E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5DB19-4F56-4949-8379-62BA31CFC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889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2998731-27C9-B5C7-E5EE-7C1928768E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526273D-85FF-4D45-A68B-A16F8C5DCD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653BAEA-EF02-3AD0-4F7A-9F0712A2F0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7AB95A-3767-4BDB-A7EF-C2479F7326CA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F4CBB5F-D8B8-F3C6-96B8-CCFC0B57D5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4D8A80F-8D52-256E-04D2-8170EA8A2E7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C5DB19-4F56-4949-8379-62BA31CFC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79735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AF1274A1-F30F-6D8B-622B-7CA94D4139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3482" y="132472"/>
            <a:ext cx="10924944" cy="5519028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DD5D5B94-C9A8-30AC-1D6F-994608C5EF50}"/>
              </a:ext>
            </a:extLst>
          </p:cNvPr>
          <p:cNvSpPr txBox="1"/>
          <p:nvPr/>
        </p:nvSpPr>
        <p:spPr>
          <a:xfrm>
            <a:off x="838200" y="5525199"/>
            <a:ext cx="1092494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 Collinearity of chromosome 1A and the region of Hg1 among CS and pangenomes, the triangular markers are the locations of corresponding genes for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esCSU02G143200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CS and pangenomes. IWGSC:CS, STA: 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DC_Stanley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DM: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DC_Landmark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SP:PI190962, JAG: Jagger, JUL: Julius, NOR: Norin61, SYM: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_Matti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RI: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inaLrFor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AC: Mace,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: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cer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10717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82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n Hu</dc:creator>
  <cp:lastModifiedBy>Xin Hu</cp:lastModifiedBy>
  <cp:revision>2</cp:revision>
  <dcterms:created xsi:type="dcterms:W3CDTF">2022-05-06T08:18:44Z</dcterms:created>
  <dcterms:modified xsi:type="dcterms:W3CDTF">2022-05-06T08:29:38Z</dcterms:modified>
</cp:coreProperties>
</file>